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10375" cy="99425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349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lomka, Marek" userId="b5697613-81d3-4318-a926-46b10f876ab5" providerId="ADAL" clId="{00F7C47E-B72D-4D4D-97E2-6B54173C8CBF}"/>
    <pc:docChg chg="modSld">
      <pc:chgData name="Slomka, Marek" userId="b5697613-81d3-4318-a926-46b10f876ab5" providerId="ADAL" clId="{00F7C47E-B72D-4D4D-97E2-6B54173C8CBF}" dt="2023-04-17T12:23:12.907" v="6" actId="20577"/>
      <pc:docMkLst>
        <pc:docMk/>
      </pc:docMkLst>
      <pc:sldChg chg="modSp mod">
        <pc:chgData name="Slomka, Marek" userId="b5697613-81d3-4318-a926-46b10f876ab5" providerId="ADAL" clId="{00F7C47E-B72D-4D4D-97E2-6B54173C8CBF}" dt="2023-04-17T12:23:12.907" v="6" actId="20577"/>
        <pc:sldMkLst>
          <pc:docMk/>
          <pc:sldMk cId="2032760477" sldId="257"/>
        </pc:sldMkLst>
        <pc:spChg chg="mod">
          <ac:chgData name="Slomka, Marek" userId="b5697613-81d3-4318-a926-46b10f876ab5" providerId="ADAL" clId="{00F7C47E-B72D-4D4D-97E2-6B54173C8CBF}" dt="2023-04-17T12:23:12.907" v="6" actId="20577"/>
          <ac:spMkLst>
            <pc:docMk/>
            <pc:sldMk cId="2032760477" sldId="257"/>
            <ac:spMk id="5" creationId="{55F31641-90DE-491B-BE9A-B80820EE4D1E}"/>
          </ac:spMkLst>
        </pc:spChg>
      </pc:sldChg>
    </pc:docChg>
  </pc:docChgLst>
  <pc:docChgLst>
    <pc:chgData name="Slomka, Marek" userId="b5697613-81d3-4318-a926-46b10f876ab5" providerId="ADAL" clId="{56713FCE-6EB0-444D-8410-E9513170D5D2}"/>
    <pc:docChg chg="modSld">
      <pc:chgData name="Slomka, Marek" userId="b5697613-81d3-4318-a926-46b10f876ab5" providerId="ADAL" clId="{56713FCE-6EB0-444D-8410-E9513170D5D2}" dt="2022-09-20T11:37:35.254" v="45" actId="1035"/>
      <pc:docMkLst>
        <pc:docMk/>
      </pc:docMkLst>
      <pc:sldChg chg="addSp modSp mod">
        <pc:chgData name="Slomka, Marek" userId="b5697613-81d3-4318-a926-46b10f876ab5" providerId="ADAL" clId="{56713FCE-6EB0-444D-8410-E9513170D5D2}" dt="2022-09-20T11:37:35.254" v="45" actId="1035"/>
        <pc:sldMkLst>
          <pc:docMk/>
          <pc:sldMk cId="2032760477" sldId="257"/>
        </pc:sldMkLst>
        <pc:spChg chg="mod">
          <ac:chgData name="Slomka, Marek" userId="b5697613-81d3-4318-a926-46b10f876ab5" providerId="ADAL" clId="{56713FCE-6EB0-444D-8410-E9513170D5D2}" dt="2022-09-20T11:35:13.350" v="24" actId="1035"/>
          <ac:spMkLst>
            <pc:docMk/>
            <pc:sldMk cId="2032760477" sldId="257"/>
            <ac:spMk id="3" creationId="{F36D46C1-9CC0-4020-9577-DA7E35BCED04}"/>
          </ac:spMkLst>
        </pc:spChg>
        <pc:spChg chg="mod">
          <ac:chgData name="Slomka, Marek" userId="b5697613-81d3-4318-a926-46b10f876ab5" providerId="ADAL" clId="{56713FCE-6EB0-444D-8410-E9513170D5D2}" dt="2022-09-20T11:35:13.350" v="24" actId="1035"/>
          <ac:spMkLst>
            <pc:docMk/>
            <pc:sldMk cId="2032760477" sldId="257"/>
            <ac:spMk id="4" creationId="{6424D4FE-B383-41E7-AB64-4FAD4D89750C}"/>
          </ac:spMkLst>
        </pc:spChg>
        <pc:spChg chg="add mod">
          <ac:chgData name="Slomka, Marek" userId="b5697613-81d3-4318-a926-46b10f876ab5" providerId="ADAL" clId="{56713FCE-6EB0-444D-8410-E9513170D5D2}" dt="2022-09-20T11:37:35.254" v="45" actId="1035"/>
          <ac:spMkLst>
            <pc:docMk/>
            <pc:sldMk cId="2032760477" sldId="257"/>
            <ac:spMk id="5" creationId="{55F31641-90DE-491B-BE9A-B80820EE4D1E}"/>
          </ac:spMkLst>
        </pc:spChg>
        <pc:graphicFrameChg chg="mod">
          <ac:chgData name="Slomka, Marek" userId="b5697613-81d3-4318-a926-46b10f876ab5" providerId="ADAL" clId="{56713FCE-6EB0-444D-8410-E9513170D5D2}" dt="2022-09-20T11:35:13.350" v="24" actId="1035"/>
          <ac:graphicFrameMkLst>
            <pc:docMk/>
            <pc:sldMk cId="2032760477" sldId="257"/>
            <ac:graphicFrameMk id="2" creationId="{47AD85D1-F6CA-40DF-92B4-1FBAD924AF03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683D0-F9CB-4C5D-9431-BF7B4673951D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6825-069B-4B35-BDA3-D33E705329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7263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683D0-F9CB-4C5D-9431-BF7B4673951D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6825-069B-4B35-BDA3-D33E705329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5975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683D0-F9CB-4C5D-9431-BF7B4673951D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6825-069B-4B35-BDA3-D33E705329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3913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683D0-F9CB-4C5D-9431-BF7B4673951D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6825-069B-4B35-BDA3-D33E705329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3474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683D0-F9CB-4C5D-9431-BF7B4673951D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6825-069B-4B35-BDA3-D33E705329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19338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683D0-F9CB-4C5D-9431-BF7B4673951D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6825-069B-4B35-BDA3-D33E705329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6768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683D0-F9CB-4C5D-9431-BF7B4673951D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6825-069B-4B35-BDA3-D33E705329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7720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683D0-F9CB-4C5D-9431-BF7B4673951D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6825-069B-4B35-BDA3-D33E705329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8874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683D0-F9CB-4C5D-9431-BF7B4673951D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6825-069B-4B35-BDA3-D33E705329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4690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683D0-F9CB-4C5D-9431-BF7B4673951D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6825-069B-4B35-BDA3-D33E705329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99801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683D0-F9CB-4C5D-9431-BF7B4673951D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46825-069B-4B35-BDA3-D33E705329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50377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683D0-F9CB-4C5D-9431-BF7B4673951D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546825-069B-4B35-BDA3-D33E705329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19332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47AD85D1-F6CA-40DF-92B4-1FBAD924AF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4210210"/>
              </p:ext>
            </p:extLst>
          </p:nvPr>
        </p:nvGraphicFramePr>
        <p:xfrm>
          <a:off x="901700" y="801688"/>
          <a:ext cx="5054600" cy="9318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5054145" imgH="9319100" progId="Prism8.Document">
                  <p:embed/>
                </p:oleObj>
              </mc:Choice>
              <mc:Fallback>
                <p:oleObj name="Prism 8" r:id="rId2" imgW="5054145" imgH="9319100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47AD85D1-F6CA-40DF-92B4-1FBAD924AF0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01700" y="801688"/>
                        <a:ext cx="5054600" cy="9318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36D46C1-9CC0-4020-9577-DA7E35BCED04}"/>
              </a:ext>
            </a:extLst>
          </p:cNvPr>
          <p:cNvSpPr txBox="1"/>
          <p:nvPr/>
        </p:nvSpPr>
        <p:spPr>
          <a:xfrm>
            <a:off x="839028" y="1032438"/>
            <a:ext cx="486750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dirty="0"/>
              <a:t>          </a:t>
            </a:r>
            <a:r>
              <a:rPr lang="en-GB" sz="2400" dirty="0"/>
              <a:t>a)</a:t>
            </a:r>
            <a:r>
              <a:rPr lang="en-GB" dirty="0"/>
              <a:t>  </a:t>
            </a:r>
            <a:r>
              <a:rPr lang="en-GB" sz="2000" dirty="0"/>
              <a:t>n=20; 20/20 infecte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424D4FE-B383-41E7-AB64-4FAD4D89750C}"/>
              </a:ext>
            </a:extLst>
          </p:cNvPr>
          <p:cNvSpPr txBox="1"/>
          <p:nvPr/>
        </p:nvSpPr>
        <p:spPr>
          <a:xfrm>
            <a:off x="1166368" y="5601912"/>
            <a:ext cx="4506299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2400" dirty="0"/>
              <a:t>   b) </a:t>
            </a:r>
            <a:r>
              <a:rPr lang="en-GB" dirty="0"/>
              <a:t> </a:t>
            </a:r>
            <a:r>
              <a:rPr lang="en-GB" sz="2000" dirty="0"/>
              <a:t>n=20; 20/20 infected</a:t>
            </a:r>
          </a:p>
          <a:p>
            <a:endParaRPr lang="en-GB" sz="8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5F31641-90DE-491B-BE9A-B80820EE4D1E}"/>
              </a:ext>
            </a:extLst>
          </p:cNvPr>
          <p:cNvSpPr txBox="1"/>
          <p:nvPr/>
        </p:nvSpPr>
        <p:spPr>
          <a:xfrm>
            <a:off x="0" y="9872663"/>
            <a:ext cx="6858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:  </a:t>
            </a:r>
            <a:r>
              <a:rPr lang="en-GB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ribution of Ct values as a measure OP and C shedding at two pheasant IPs identified in February 2022.  Panels (a) and (b) show the Ct values for the pheasant IPs 36 and 37 (Table 1).  </a:t>
            </a:r>
            <a:r>
              <a:rPr lang="en-GB" sz="14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e Figure </a:t>
            </a:r>
            <a:r>
              <a:rPr lang="en-GB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 legend for other details.</a:t>
            </a:r>
            <a:r>
              <a:rPr lang="en-GB" sz="1400" b="1" i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endParaRPr lang="en-GB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27604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72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lomka, Marek</dc:creator>
  <cp:lastModifiedBy>Slomka, Marek</cp:lastModifiedBy>
  <cp:revision>1</cp:revision>
  <cp:lastPrinted>2022-05-19T11:16:08Z</cp:lastPrinted>
  <dcterms:created xsi:type="dcterms:W3CDTF">2022-05-19T11:12:35Z</dcterms:created>
  <dcterms:modified xsi:type="dcterms:W3CDTF">2023-04-17T12:23:17Z</dcterms:modified>
</cp:coreProperties>
</file>